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256" r:id="rId2"/>
    <p:sldId id="263" r:id="rId3"/>
    <p:sldId id="258" r:id="rId4"/>
    <p:sldId id="262" r:id="rId5"/>
    <p:sldId id="265" r:id="rId6"/>
    <p:sldId id="264" r:id="rId7"/>
    <p:sldId id="266" r:id="rId8"/>
    <p:sldId id="267" r:id="rId9"/>
    <p:sldId id="268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Oldřich Trněný" initials="OT" lastIdx="1" clrIdx="0">
    <p:extLst>
      <p:ext uri="{19B8F6BF-5375-455C-9EA6-DF929625EA0E}">
        <p15:presenceInfo xmlns:p15="http://schemas.microsoft.com/office/powerpoint/2012/main" userId="S-1-5-21-3347075266-284640999-234003212-1127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6" d="100"/>
          <a:sy n="106" d="100"/>
        </p:scale>
        <p:origin x="756" y="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commentAuthors" Target="commentAuthors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záhlaví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/>
          </a:p>
        </p:txBody>
      </p:sp>
      <p:sp>
        <p:nvSpPr>
          <p:cNvPr id="3" name="Zástupný symbol pro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2E1CDC2-9C5E-45BE-B4D7-BE8756304481}" type="datetimeFigureOut">
              <a:rPr lang="cs-CZ" smtClean="0"/>
              <a:t>25.11.2022</a:t>
            </a:fld>
            <a:endParaRPr lang="cs-CZ"/>
          </a:p>
        </p:txBody>
      </p:sp>
      <p:sp>
        <p:nvSpPr>
          <p:cNvPr id="4" name="Zástupný symbol pro obrázek snímku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/>
          </a:p>
        </p:txBody>
      </p:sp>
      <p:sp>
        <p:nvSpPr>
          <p:cNvPr id="5" name="Zástupný symbol pro poznámky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B9AF519-2654-43E4-B71D-2E0265E29D6F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2981694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obrázek snímku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Zástupný symbol pro poznámky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cs-CZ" dirty="0"/>
          </a:p>
        </p:txBody>
      </p:sp>
      <p:sp>
        <p:nvSpPr>
          <p:cNvPr id="4" name="Zástupný symbol pro číslo snímku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B9AF519-2654-43E4-B71D-2E0265E29D6F}" type="slidenum">
              <a:rPr lang="cs-CZ" smtClean="0"/>
              <a:t>8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38178091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BA7F7F17-9039-4A2B-9C17-CC1AA13A726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cs-CZ"/>
              <a:t>Kliknutím lze upravit styl.</a:t>
            </a:r>
            <a:endParaRPr lang="en-GB"/>
          </a:p>
        </p:txBody>
      </p:sp>
      <p:sp>
        <p:nvSpPr>
          <p:cNvPr id="3" name="Podnadpis 2">
            <a:extLst>
              <a:ext uri="{FF2B5EF4-FFF2-40B4-BE49-F238E27FC236}">
                <a16:creationId xmlns:a16="http://schemas.microsoft.com/office/drawing/2014/main" id="{3ADBB4B4-31DD-4839-9047-84EBCBD970B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cs-CZ"/>
              <a:t>Kliknutím můžete upravit styl předlohy.</a:t>
            </a:r>
            <a:endParaRPr lang="en-GB"/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0F9F2267-C931-4E45-A23B-9A23452295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0715B-6E96-4DF5-8A23-E36F318C3F06}" type="datetimeFigureOut">
              <a:rPr lang="en-GB" smtClean="0"/>
              <a:t>25/11/2022</a:t>
            </a:fld>
            <a:endParaRPr lang="en-GB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C0F5D5DE-1EF0-4020-8F12-B2908D7AE8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F136303B-E688-4203-9EAA-BD94D3A7BD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050917-7E50-46F4-98BB-082FB0BD65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559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AF50327A-2DBE-41A6-8387-838E53415D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  <a:endParaRPr lang="en-GB"/>
          </a:p>
        </p:txBody>
      </p:sp>
      <p:sp>
        <p:nvSpPr>
          <p:cNvPr id="3" name="Zástupný symbol pro svislý text 2">
            <a:extLst>
              <a:ext uri="{FF2B5EF4-FFF2-40B4-BE49-F238E27FC236}">
                <a16:creationId xmlns:a16="http://schemas.microsoft.com/office/drawing/2014/main" id="{1A4E67BD-82F4-4E1B-9C10-DB67FDC9962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GB"/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F29C0B27-692C-4626-9DB5-521046BED8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0715B-6E96-4DF5-8A23-E36F318C3F06}" type="datetimeFigureOut">
              <a:rPr lang="en-GB" smtClean="0"/>
              <a:t>25/11/2022</a:t>
            </a:fld>
            <a:endParaRPr lang="en-GB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8405C3E4-8E4E-4728-87A7-DD0C3C0B4A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0124CCC4-2816-4381-8866-D7C106F05B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050917-7E50-46F4-98BB-082FB0BD65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54556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vislý nadpis 1">
            <a:extLst>
              <a:ext uri="{FF2B5EF4-FFF2-40B4-BE49-F238E27FC236}">
                <a16:creationId xmlns:a16="http://schemas.microsoft.com/office/drawing/2014/main" id="{C9797D55-F289-4E4A-B293-E2060C3E58D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cs-CZ"/>
              <a:t>Kliknutím lze upravit styl.</a:t>
            </a:r>
            <a:endParaRPr lang="en-GB"/>
          </a:p>
        </p:txBody>
      </p:sp>
      <p:sp>
        <p:nvSpPr>
          <p:cNvPr id="3" name="Zástupný symbol pro svislý text 2">
            <a:extLst>
              <a:ext uri="{FF2B5EF4-FFF2-40B4-BE49-F238E27FC236}">
                <a16:creationId xmlns:a16="http://schemas.microsoft.com/office/drawing/2014/main" id="{C9ACD967-A55D-4F46-9733-32E858AFFD6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GB"/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C8E9BC74-1B18-4B0E-B60A-80D7F699F1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0715B-6E96-4DF5-8A23-E36F318C3F06}" type="datetimeFigureOut">
              <a:rPr lang="en-GB" smtClean="0"/>
              <a:t>25/11/2022</a:t>
            </a:fld>
            <a:endParaRPr lang="en-GB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AAA7926F-E9F5-4D54-9E97-B3019937B5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EE34D0D1-18FD-4F55-9429-EB50DF69D0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050917-7E50-46F4-98BB-082FB0BD65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88889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42972943-C536-45A6-8902-0EE626B0BD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  <a:endParaRPr lang="en-GB"/>
          </a:p>
        </p:txBody>
      </p:sp>
      <p:sp>
        <p:nvSpPr>
          <p:cNvPr id="3" name="Zástupný obsah 2">
            <a:extLst>
              <a:ext uri="{FF2B5EF4-FFF2-40B4-BE49-F238E27FC236}">
                <a16:creationId xmlns:a16="http://schemas.microsoft.com/office/drawing/2014/main" id="{A5FBC489-DCB1-465E-A489-A6EE96718EA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GB"/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549AF6C5-C44B-436D-B191-CE1F98274E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0715B-6E96-4DF5-8A23-E36F318C3F06}" type="datetimeFigureOut">
              <a:rPr lang="en-GB" smtClean="0"/>
              <a:t>25/11/2022</a:t>
            </a:fld>
            <a:endParaRPr lang="en-GB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20323D4E-DB87-445A-AFF8-4DF54A47D6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A8343F21-5C62-4681-99B8-BD8DCE5DDC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050917-7E50-46F4-98BB-082FB0BD65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7012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oddíl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3FAA4BAE-13EB-4C2D-855B-AC3FA87D26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cs-CZ"/>
              <a:t>Kliknutím lze upravit styl.</a:t>
            </a:r>
            <a:endParaRPr lang="en-GB"/>
          </a:p>
        </p:txBody>
      </p:sp>
      <p:sp>
        <p:nvSpPr>
          <p:cNvPr id="3" name="Zástupný text 2">
            <a:extLst>
              <a:ext uri="{FF2B5EF4-FFF2-40B4-BE49-F238E27FC236}">
                <a16:creationId xmlns:a16="http://schemas.microsoft.com/office/drawing/2014/main" id="{A46E4A25-9B1F-4AD8-B692-1D9CB3FF54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DCA177CF-2AC7-4857-A873-507547C382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0715B-6E96-4DF5-8A23-E36F318C3F06}" type="datetimeFigureOut">
              <a:rPr lang="en-GB" smtClean="0"/>
              <a:t>25/11/2022</a:t>
            </a:fld>
            <a:endParaRPr lang="en-GB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EAE659E1-32E6-45A8-A82A-A586E73D0A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2FE6A916-07C6-45BE-AE2B-9D1A051ED3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050917-7E50-46F4-98BB-082FB0BD65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74529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BB080A38-E2DD-49D7-9313-07C9675FE6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  <a:endParaRPr lang="en-GB"/>
          </a:p>
        </p:txBody>
      </p:sp>
      <p:sp>
        <p:nvSpPr>
          <p:cNvPr id="3" name="Zástupný obsah 2">
            <a:extLst>
              <a:ext uri="{FF2B5EF4-FFF2-40B4-BE49-F238E27FC236}">
                <a16:creationId xmlns:a16="http://schemas.microsoft.com/office/drawing/2014/main" id="{9E1FB1DB-062C-4E7D-807D-36C83B27D79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GB"/>
          </a:p>
        </p:txBody>
      </p:sp>
      <p:sp>
        <p:nvSpPr>
          <p:cNvPr id="4" name="Zástupný obsah 3">
            <a:extLst>
              <a:ext uri="{FF2B5EF4-FFF2-40B4-BE49-F238E27FC236}">
                <a16:creationId xmlns:a16="http://schemas.microsoft.com/office/drawing/2014/main" id="{7E4A7A18-89AB-4546-A220-E9ABA80F6A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GB"/>
          </a:p>
        </p:txBody>
      </p:sp>
      <p:sp>
        <p:nvSpPr>
          <p:cNvPr id="5" name="Zástupný symbol pro datum 4">
            <a:extLst>
              <a:ext uri="{FF2B5EF4-FFF2-40B4-BE49-F238E27FC236}">
                <a16:creationId xmlns:a16="http://schemas.microsoft.com/office/drawing/2014/main" id="{BE0215D5-ECBA-447D-B4B9-37234B9738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0715B-6E96-4DF5-8A23-E36F318C3F06}" type="datetimeFigureOut">
              <a:rPr lang="en-GB" smtClean="0"/>
              <a:t>25/11/2022</a:t>
            </a:fld>
            <a:endParaRPr lang="en-GB"/>
          </a:p>
        </p:txBody>
      </p:sp>
      <p:sp>
        <p:nvSpPr>
          <p:cNvPr id="6" name="Zástupný symbol pro zápatí 5">
            <a:extLst>
              <a:ext uri="{FF2B5EF4-FFF2-40B4-BE49-F238E27FC236}">
                <a16:creationId xmlns:a16="http://schemas.microsoft.com/office/drawing/2014/main" id="{70A9CD83-FF83-4E0E-A98B-5355A620B0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Zástupný symbol pro číslo snímku 6">
            <a:extLst>
              <a:ext uri="{FF2B5EF4-FFF2-40B4-BE49-F238E27FC236}">
                <a16:creationId xmlns:a16="http://schemas.microsoft.com/office/drawing/2014/main" id="{CABF0996-9279-4EAC-B7D9-624C5FE6D8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050917-7E50-46F4-98BB-082FB0BD65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83051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C1F1A3AC-F433-4663-9D18-AE23EE7EDE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cs-CZ"/>
              <a:t>Kliknutím lze upravit styl.</a:t>
            </a:r>
            <a:endParaRPr lang="en-GB"/>
          </a:p>
        </p:txBody>
      </p:sp>
      <p:sp>
        <p:nvSpPr>
          <p:cNvPr id="3" name="Zástupný text 2">
            <a:extLst>
              <a:ext uri="{FF2B5EF4-FFF2-40B4-BE49-F238E27FC236}">
                <a16:creationId xmlns:a16="http://schemas.microsoft.com/office/drawing/2014/main" id="{A3CF8B0C-6765-48EA-B2A5-40F3A76D21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4" name="Zástupný obsah 3">
            <a:extLst>
              <a:ext uri="{FF2B5EF4-FFF2-40B4-BE49-F238E27FC236}">
                <a16:creationId xmlns:a16="http://schemas.microsoft.com/office/drawing/2014/main" id="{0B2B14AE-E1D1-4077-B9F9-4E5ED0AB74C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GB"/>
          </a:p>
        </p:txBody>
      </p:sp>
      <p:sp>
        <p:nvSpPr>
          <p:cNvPr id="5" name="Zástupný text 4">
            <a:extLst>
              <a:ext uri="{FF2B5EF4-FFF2-40B4-BE49-F238E27FC236}">
                <a16:creationId xmlns:a16="http://schemas.microsoft.com/office/drawing/2014/main" id="{C02A552D-8B47-4BAD-955E-603FB1110F7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6" name="Zástupný obsah 5">
            <a:extLst>
              <a:ext uri="{FF2B5EF4-FFF2-40B4-BE49-F238E27FC236}">
                <a16:creationId xmlns:a16="http://schemas.microsoft.com/office/drawing/2014/main" id="{61222E00-DFFF-4D38-BFF2-6F5527C73AC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GB"/>
          </a:p>
        </p:txBody>
      </p:sp>
      <p:sp>
        <p:nvSpPr>
          <p:cNvPr id="7" name="Zástupný symbol pro datum 6">
            <a:extLst>
              <a:ext uri="{FF2B5EF4-FFF2-40B4-BE49-F238E27FC236}">
                <a16:creationId xmlns:a16="http://schemas.microsoft.com/office/drawing/2014/main" id="{8C4601D2-E0BF-4621-8D9F-04D811B78D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0715B-6E96-4DF5-8A23-E36F318C3F06}" type="datetimeFigureOut">
              <a:rPr lang="en-GB" smtClean="0"/>
              <a:t>25/11/2022</a:t>
            </a:fld>
            <a:endParaRPr lang="en-GB"/>
          </a:p>
        </p:txBody>
      </p:sp>
      <p:sp>
        <p:nvSpPr>
          <p:cNvPr id="8" name="Zástupný symbol pro zápatí 7">
            <a:extLst>
              <a:ext uri="{FF2B5EF4-FFF2-40B4-BE49-F238E27FC236}">
                <a16:creationId xmlns:a16="http://schemas.microsoft.com/office/drawing/2014/main" id="{62B64B7D-29B9-4261-8E71-99D8449260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Zástupný symbol pro číslo snímku 8">
            <a:extLst>
              <a:ext uri="{FF2B5EF4-FFF2-40B4-BE49-F238E27FC236}">
                <a16:creationId xmlns:a16="http://schemas.microsoft.com/office/drawing/2014/main" id="{030E79F3-45E5-4FEF-942C-51A1DFD3A9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050917-7E50-46F4-98BB-082FB0BD65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30888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Jenom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12032B7F-8716-4D93-875E-2DA9E3ACA2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  <a:endParaRPr lang="en-GB"/>
          </a:p>
        </p:txBody>
      </p:sp>
      <p:sp>
        <p:nvSpPr>
          <p:cNvPr id="3" name="Zástupný symbol pro datum 2">
            <a:extLst>
              <a:ext uri="{FF2B5EF4-FFF2-40B4-BE49-F238E27FC236}">
                <a16:creationId xmlns:a16="http://schemas.microsoft.com/office/drawing/2014/main" id="{456066FB-F463-4824-A01B-2A18ED1912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0715B-6E96-4DF5-8A23-E36F318C3F06}" type="datetimeFigureOut">
              <a:rPr lang="en-GB" smtClean="0"/>
              <a:t>25/11/2022</a:t>
            </a:fld>
            <a:endParaRPr lang="en-GB"/>
          </a:p>
        </p:txBody>
      </p:sp>
      <p:sp>
        <p:nvSpPr>
          <p:cNvPr id="4" name="Zástupný symbol pro zápatí 3">
            <a:extLst>
              <a:ext uri="{FF2B5EF4-FFF2-40B4-BE49-F238E27FC236}">
                <a16:creationId xmlns:a16="http://schemas.microsoft.com/office/drawing/2014/main" id="{962242D3-6541-44F0-A257-F151E1A9D6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Zástupný symbol pro číslo snímku 4">
            <a:extLst>
              <a:ext uri="{FF2B5EF4-FFF2-40B4-BE49-F238E27FC236}">
                <a16:creationId xmlns:a16="http://schemas.microsoft.com/office/drawing/2014/main" id="{3EC7B352-B32F-489F-A5A1-AC3E18FF63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050917-7E50-46F4-98BB-082FB0BD65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87966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datum 1">
            <a:extLst>
              <a:ext uri="{FF2B5EF4-FFF2-40B4-BE49-F238E27FC236}">
                <a16:creationId xmlns:a16="http://schemas.microsoft.com/office/drawing/2014/main" id="{B62A0EFD-7CB4-48FE-9B9E-0EE9B84D9D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0715B-6E96-4DF5-8A23-E36F318C3F06}" type="datetimeFigureOut">
              <a:rPr lang="en-GB" smtClean="0"/>
              <a:t>25/11/2022</a:t>
            </a:fld>
            <a:endParaRPr lang="en-GB"/>
          </a:p>
        </p:txBody>
      </p:sp>
      <p:sp>
        <p:nvSpPr>
          <p:cNvPr id="3" name="Zástupný symbol pro zápatí 2">
            <a:extLst>
              <a:ext uri="{FF2B5EF4-FFF2-40B4-BE49-F238E27FC236}">
                <a16:creationId xmlns:a16="http://schemas.microsoft.com/office/drawing/2014/main" id="{77DB3AE3-3390-4A0A-9707-88209E9D51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Zástupný symbol pro číslo snímku 3">
            <a:extLst>
              <a:ext uri="{FF2B5EF4-FFF2-40B4-BE49-F238E27FC236}">
                <a16:creationId xmlns:a16="http://schemas.microsoft.com/office/drawing/2014/main" id="{78076962-EB37-4BED-AEBD-1DBE957F98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050917-7E50-46F4-98BB-082FB0BD65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29187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B6BCA2A0-E334-4D36-862A-73AFB59D5A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s-CZ"/>
              <a:t>Kliknutím lze upravit styl.</a:t>
            </a:r>
            <a:endParaRPr lang="en-GB"/>
          </a:p>
        </p:txBody>
      </p:sp>
      <p:sp>
        <p:nvSpPr>
          <p:cNvPr id="3" name="Zástupný obsah 2">
            <a:extLst>
              <a:ext uri="{FF2B5EF4-FFF2-40B4-BE49-F238E27FC236}">
                <a16:creationId xmlns:a16="http://schemas.microsoft.com/office/drawing/2014/main" id="{F5E682E3-0AF6-44AC-9AA6-D7CEECED923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GB"/>
          </a:p>
        </p:txBody>
      </p:sp>
      <p:sp>
        <p:nvSpPr>
          <p:cNvPr id="4" name="Zástupný text 3">
            <a:extLst>
              <a:ext uri="{FF2B5EF4-FFF2-40B4-BE49-F238E27FC236}">
                <a16:creationId xmlns:a16="http://schemas.microsoft.com/office/drawing/2014/main" id="{1C804624-746B-4ED5-969F-C84EEA3609E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5" name="Zástupný symbol pro datum 4">
            <a:extLst>
              <a:ext uri="{FF2B5EF4-FFF2-40B4-BE49-F238E27FC236}">
                <a16:creationId xmlns:a16="http://schemas.microsoft.com/office/drawing/2014/main" id="{15A3ABDF-5C84-43BD-87F1-AF6331EDE9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0715B-6E96-4DF5-8A23-E36F318C3F06}" type="datetimeFigureOut">
              <a:rPr lang="en-GB" smtClean="0"/>
              <a:t>25/11/2022</a:t>
            </a:fld>
            <a:endParaRPr lang="en-GB"/>
          </a:p>
        </p:txBody>
      </p:sp>
      <p:sp>
        <p:nvSpPr>
          <p:cNvPr id="6" name="Zástupný symbol pro zápatí 5">
            <a:extLst>
              <a:ext uri="{FF2B5EF4-FFF2-40B4-BE49-F238E27FC236}">
                <a16:creationId xmlns:a16="http://schemas.microsoft.com/office/drawing/2014/main" id="{1E1DAE2B-CEAB-4569-941F-A96F80240F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Zástupný symbol pro číslo snímku 6">
            <a:extLst>
              <a:ext uri="{FF2B5EF4-FFF2-40B4-BE49-F238E27FC236}">
                <a16:creationId xmlns:a16="http://schemas.microsoft.com/office/drawing/2014/main" id="{CC2A7EBB-0128-44D9-A1AE-B9F69F61AC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050917-7E50-46F4-98BB-082FB0BD65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54201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720C99B1-8B65-46F6-91C0-51EA6492B5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s-CZ"/>
              <a:t>Kliknutím lze upravit styl.</a:t>
            </a:r>
            <a:endParaRPr lang="en-GB"/>
          </a:p>
        </p:txBody>
      </p:sp>
      <p:sp>
        <p:nvSpPr>
          <p:cNvPr id="3" name="Zástupný symbol obrázku 2">
            <a:extLst>
              <a:ext uri="{FF2B5EF4-FFF2-40B4-BE49-F238E27FC236}">
                <a16:creationId xmlns:a16="http://schemas.microsoft.com/office/drawing/2014/main" id="{7DECD4D1-B371-43B5-BBCE-AC561B83AD0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Zástupný text 3">
            <a:extLst>
              <a:ext uri="{FF2B5EF4-FFF2-40B4-BE49-F238E27FC236}">
                <a16:creationId xmlns:a16="http://schemas.microsoft.com/office/drawing/2014/main" id="{CC054C41-CC8A-44BC-9856-D8A03F46108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5" name="Zástupný symbol pro datum 4">
            <a:extLst>
              <a:ext uri="{FF2B5EF4-FFF2-40B4-BE49-F238E27FC236}">
                <a16:creationId xmlns:a16="http://schemas.microsoft.com/office/drawing/2014/main" id="{C919E9DF-E69D-4B00-A6D7-5473491462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0715B-6E96-4DF5-8A23-E36F318C3F06}" type="datetimeFigureOut">
              <a:rPr lang="en-GB" smtClean="0"/>
              <a:t>25/11/2022</a:t>
            </a:fld>
            <a:endParaRPr lang="en-GB"/>
          </a:p>
        </p:txBody>
      </p:sp>
      <p:sp>
        <p:nvSpPr>
          <p:cNvPr id="6" name="Zástupný symbol pro zápatí 5">
            <a:extLst>
              <a:ext uri="{FF2B5EF4-FFF2-40B4-BE49-F238E27FC236}">
                <a16:creationId xmlns:a16="http://schemas.microsoft.com/office/drawing/2014/main" id="{9E5C75FF-D26A-4FD7-A5C3-5D8F29330A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Zástupný symbol pro číslo snímku 6">
            <a:extLst>
              <a:ext uri="{FF2B5EF4-FFF2-40B4-BE49-F238E27FC236}">
                <a16:creationId xmlns:a16="http://schemas.microsoft.com/office/drawing/2014/main" id="{7E6404A1-92D2-4477-9B72-2C39A1724C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050917-7E50-46F4-98BB-082FB0BD65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6932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nadpis 1">
            <a:extLst>
              <a:ext uri="{FF2B5EF4-FFF2-40B4-BE49-F238E27FC236}">
                <a16:creationId xmlns:a16="http://schemas.microsoft.com/office/drawing/2014/main" id="{DB7D1F6A-4A27-400A-B9CF-4871CAA3C8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/>
              <a:t>Kliknutím lze upravit styl.</a:t>
            </a:r>
            <a:endParaRPr lang="en-GB"/>
          </a:p>
        </p:txBody>
      </p:sp>
      <p:sp>
        <p:nvSpPr>
          <p:cNvPr id="3" name="Zástupný text 2">
            <a:extLst>
              <a:ext uri="{FF2B5EF4-FFF2-40B4-BE49-F238E27FC236}">
                <a16:creationId xmlns:a16="http://schemas.microsoft.com/office/drawing/2014/main" id="{946CDC22-BE10-45A2-BBB6-095CAAD0C5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GB"/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5617589D-CEE6-45C6-AF09-2348BD4F2EB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20715B-6E96-4DF5-8A23-E36F318C3F06}" type="datetimeFigureOut">
              <a:rPr lang="en-GB" smtClean="0"/>
              <a:t>25/11/2022</a:t>
            </a:fld>
            <a:endParaRPr lang="en-GB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8715F050-7226-4CDE-B629-B238432F52C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DAE6F16B-D3AD-4A19-BBDF-C5F4F32F119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050917-7E50-46F4-98BB-082FB0BD65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27003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16B27AF2-D3F4-4F96-98E9-B33482BD1A5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3999" y="1122363"/>
            <a:ext cx="9626353" cy="2387600"/>
          </a:xfrm>
        </p:spPr>
        <p:txBody>
          <a:bodyPr/>
          <a:lstStyle/>
          <a:p>
            <a:r>
              <a:rPr lang="en-GB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Supplementary material figures </a:t>
            </a:r>
          </a:p>
        </p:txBody>
      </p:sp>
    </p:spTree>
    <p:extLst>
      <p:ext uri="{BB962C8B-B14F-4D97-AF65-F5344CB8AC3E}">
        <p14:creationId xmlns:p14="http://schemas.microsoft.com/office/powerpoint/2010/main" val="19745592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rázek 1" descr="Obsah obrázku text, snímek obrazovky, klimatizace, vektorová grafika&#10;&#10;Popis byl vytvořen automaticky">
            <a:extLst>
              <a:ext uri="{FF2B5EF4-FFF2-40B4-BE49-F238E27FC236}">
                <a16:creationId xmlns:a16="http://schemas.microsoft.com/office/drawing/2014/main" id="{F623EC35-A80D-251C-D818-6DF9B3E8D37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9214" y="87591"/>
            <a:ext cx="6082690" cy="6792018"/>
          </a:xfrm>
          <a:prstGeom prst="rect">
            <a:avLst/>
          </a:prstGeom>
        </p:spPr>
      </p:pic>
      <p:sp>
        <p:nvSpPr>
          <p:cNvPr id="6" name="TextovéPole 5">
            <a:extLst>
              <a:ext uri="{FF2B5EF4-FFF2-40B4-BE49-F238E27FC236}">
                <a16:creationId xmlns:a16="http://schemas.microsoft.com/office/drawing/2014/main" id="{9EEC67B1-38EA-AAEC-AE3B-80A11E0D70D6}"/>
              </a:ext>
            </a:extLst>
          </p:cNvPr>
          <p:cNvSpPr txBox="1"/>
          <p:nvPr/>
        </p:nvSpPr>
        <p:spPr>
          <a:xfrm>
            <a:off x="7153153" y="1180618"/>
            <a:ext cx="4166887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. </a:t>
            </a:r>
            <a:r>
              <a:rPr lang="en-GB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raphical summary of the quality control after mapping reads. The individual colours represent the distinct samples, the dashed lines indicate the median values across all samples.</a:t>
            </a:r>
          </a:p>
          <a:p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1784151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ovéPole 5">
            <a:extLst>
              <a:ext uri="{FF2B5EF4-FFF2-40B4-BE49-F238E27FC236}">
                <a16:creationId xmlns:a16="http://schemas.microsoft.com/office/drawing/2014/main" id="{A57B4577-3FB4-88FB-A7EA-7E17257FB3BA}"/>
              </a:ext>
            </a:extLst>
          </p:cNvPr>
          <p:cNvSpPr txBox="1"/>
          <p:nvPr/>
        </p:nvSpPr>
        <p:spPr>
          <a:xfrm>
            <a:off x="1134319" y="5856791"/>
            <a:ext cx="9433367" cy="8735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  <a:spcAft>
                <a:spcPts val="800"/>
              </a:spcAft>
            </a:pPr>
            <a:r>
              <a:rPr lang="en-GB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GB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2. </a:t>
            </a:r>
            <a:r>
              <a:rPr lang="en-GB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earson correlation coefficient of </a:t>
            </a:r>
            <a:r>
              <a:rPr lang="en-GB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log</a:t>
            </a:r>
            <a:r>
              <a:rPr lang="en-GB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normalized biological replicates</a:t>
            </a:r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for accession </a:t>
            </a:r>
            <a:r>
              <a:rPr lang="cs-CZ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57</a:t>
            </a:r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/</a:t>
            </a:r>
            <a:r>
              <a:rPr lang="cs-CZ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2</a:t>
            </a:r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 </a:t>
            </a:r>
          </a:p>
        </p:txBody>
      </p:sp>
      <p:pic>
        <p:nvPicPr>
          <p:cNvPr id="3" name="Obrázek 2">
            <a:extLst>
              <a:ext uri="{FF2B5EF4-FFF2-40B4-BE49-F238E27FC236}">
                <a16:creationId xmlns:a16="http://schemas.microsoft.com/office/drawing/2014/main" id="{8EE37187-D8E7-6AA6-49C5-330AC8250A5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8664" y="9135"/>
            <a:ext cx="10000045" cy="58823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3491717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ovéPole 4">
            <a:extLst>
              <a:ext uri="{FF2B5EF4-FFF2-40B4-BE49-F238E27FC236}">
                <a16:creationId xmlns:a16="http://schemas.microsoft.com/office/drawing/2014/main" id="{1F5FD3E8-2314-D0E7-CBC0-BCA9F9D6391E}"/>
              </a:ext>
            </a:extLst>
          </p:cNvPr>
          <p:cNvSpPr txBox="1"/>
          <p:nvPr/>
        </p:nvSpPr>
        <p:spPr>
          <a:xfrm>
            <a:off x="1894910" y="5787341"/>
            <a:ext cx="906631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GB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3. </a:t>
            </a:r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ndrogram of </a:t>
            </a:r>
            <a:r>
              <a:rPr lang="en-GB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log</a:t>
            </a:r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transformed read counts for 23 different samples, using the complete linkage function. </a:t>
            </a:r>
            <a:endParaRPr lang="en-GB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Obrázek 3">
            <a:extLst>
              <a:ext uri="{FF2B5EF4-FFF2-40B4-BE49-F238E27FC236}">
                <a16:creationId xmlns:a16="http://schemas.microsoft.com/office/drawing/2014/main" id="{0B6979E4-DC72-D450-C4E4-FDC10671321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0" y="-1"/>
            <a:ext cx="9259745" cy="57873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460353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rázek 1">
            <a:extLst>
              <a:ext uri="{FF2B5EF4-FFF2-40B4-BE49-F238E27FC236}">
                <a16:creationId xmlns:a16="http://schemas.microsoft.com/office/drawing/2014/main" id="{ED90790B-0DC0-1460-7603-5E40A26E0F5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94037" y="324091"/>
            <a:ext cx="8571466" cy="4896091"/>
          </a:xfrm>
          <a:prstGeom prst="rect">
            <a:avLst/>
          </a:prstGeom>
        </p:spPr>
      </p:pic>
      <p:sp>
        <p:nvSpPr>
          <p:cNvPr id="3" name="TextovéPole 2">
            <a:extLst>
              <a:ext uri="{FF2B5EF4-FFF2-40B4-BE49-F238E27FC236}">
                <a16:creationId xmlns:a16="http://schemas.microsoft.com/office/drawing/2014/main" id="{D7A6285B-458C-5452-A175-FEA89E787365}"/>
              </a:ext>
            </a:extLst>
          </p:cNvPr>
          <p:cNvSpPr txBox="1"/>
          <p:nvPr/>
        </p:nvSpPr>
        <p:spPr>
          <a:xfrm>
            <a:off x="1041722" y="5497974"/>
            <a:ext cx="1019729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GB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4. </a:t>
            </a:r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CA plot of </a:t>
            </a:r>
            <a:r>
              <a:rPr lang="en-GB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log</a:t>
            </a:r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transformed read counts using 8 accessions (23 samples) from RNA sequencing. PC1 and PC2 indicate principal components. Colour scale indicates individual accessions; biological replicates are labelled by the same colour.</a:t>
            </a:r>
            <a:endParaRPr lang="en-GB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3227537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ovéPole 2">
            <a:extLst>
              <a:ext uri="{FF2B5EF4-FFF2-40B4-BE49-F238E27FC236}">
                <a16:creationId xmlns:a16="http://schemas.microsoft.com/office/drawing/2014/main" id="{625F2E49-20A2-5A1A-49C9-A3AB7E8C8F0C}"/>
              </a:ext>
            </a:extLst>
          </p:cNvPr>
          <p:cNvSpPr txBox="1"/>
          <p:nvPr/>
        </p:nvSpPr>
        <p:spPr>
          <a:xfrm>
            <a:off x="7080813" y="2176040"/>
            <a:ext cx="4120588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GB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5. </a:t>
            </a:r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MA plot for 37.415 genes detected in nodules. On the x-axis is average expression for detected genes, on the y-axis is expression change. Genes with adjusted </a:t>
            </a:r>
            <a:r>
              <a:rPr lang="en-GB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values &lt; 0.05 are marked in </a:t>
            </a:r>
            <a:r>
              <a:rPr lang="cs-CZ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lue</a:t>
            </a:r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n-GB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5" name="Obrázek 4">
            <a:extLst>
              <a:ext uri="{FF2B5EF4-FFF2-40B4-BE49-F238E27FC236}">
                <a16:creationId xmlns:a16="http://schemas.microsoft.com/office/drawing/2014/main" id="{C2F0FC9C-D36A-20BC-EC39-610B5797BAE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2813" y="0"/>
            <a:ext cx="6858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8232425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ovéPole 2">
            <a:extLst>
              <a:ext uri="{FF2B5EF4-FFF2-40B4-BE49-F238E27FC236}">
                <a16:creationId xmlns:a16="http://schemas.microsoft.com/office/drawing/2014/main" id="{9E3AA035-5DA4-03C0-50AF-10683E5C283E}"/>
              </a:ext>
            </a:extLst>
          </p:cNvPr>
          <p:cNvSpPr txBox="1"/>
          <p:nvPr/>
        </p:nvSpPr>
        <p:spPr>
          <a:xfrm>
            <a:off x="8021257" y="1018572"/>
            <a:ext cx="3622876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GB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6</a:t>
            </a:r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Eigengenes profiles of 16 WGCNA modules</a:t>
            </a:r>
            <a:r>
              <a:rPr lang="cs-CZ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s-CZ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cs-CZ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s-CZ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l</a:t>
            </a:r>
            <a:r>
              <a:rPr lang="cs-CZ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s-CZ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notypes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cs-CZ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Eigengene correspond</a:t>
            </a:r>
            <a:r>
              <a:rPr lang="cs-CZ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 the 1st principal component </a:t>
            </a:r>
            <a:r>
              <a:rPr lang="cs-CZ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</a:t>
            </a:r>
            <a:r>
              <a:rPr lang="cs-CZ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s within a module.</a:t>
            </a:r>
            <a:r>
              <a:rPr lang="cs-CZ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in each module </a:t>
            </a:r>
            <a:r>
              <a:rPr lang="cs-CZ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n</a:t>
            </a:r>
            <a:r>
              <a:rPr lang="cs-CZ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s-CZ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pecific for several samples or even a single sample</a:t>
            </a:r>
            <a:r>
              <a:rPr lang="cs-CZ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GB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Obrázek 4">
            <a:extLst>
              <a:ext uri="{FF2B5EF4-FFF2-40B4-BE49-F238E27FC236}">
                <a16:creationId xmlns:a16="http://schemas.microsoft.com/office/drawing/2014/main" id="{DAC61DF3-0F34-DE01-E33B-73070953704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863"/>
          <a:stretch/>
        </p:blipFill>
        <p:spPr>
          <a:xfrm>
            <a:off x="287510" y="483099"/>
            <a:ext cx="7620016" cy="57385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0839395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ovéPole 4">
            <a:extLst>
              <a:ext uri="{FF2B5EF4-FFF2-40B4-BE49-F238E27FC236}">
                <a16:creationId xmlns:a16="http://schemas.microsoft.com/office/drawing/2014/main" id="{AB01C694-1576-D2DC-F0A9-287A352D84B8}"/>
              </a:ext>
            </a:extLst>
          </p:cNvPr>
          <p:cNvSpPr txBox="1"/>
          <p:nvPr/>
        </p:nvSpPr>
        <p:spPr>
          <a:xfrm>
            <a:off x="7560295" y="454039"/>
            <a:ext cx="4242063" cy="39703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0" lang="en-GB" altLang="cs-CZ" b="1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7</a:t>
            </a:r>
            <a:r>
              <a:rPr lang="en-GB" altLang="cs-CZ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kumimoji="0" lang="en-GB" altLang="cs-CZ" b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WGCNA network based on the topological overlap matrix</a:t>
            </a:r>
            <a:r>
              <a:rPr kumimoji="0" lang="cs-CZ" altLang="cs-CZ" b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TOM)</a:t>
            </a:r>
            <a:r>
              <a:rPr kumimoji="0" lang="en-GB" altLang="cs-CZ" b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rom </a:t>
            </a:r>
            <a:r>
              <a:rPr kumimoji="0" lang="cs-CZ" altLang="cs-CZ" b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enes </a:t>
            </a:r>
            <a:r>
              <a:rPr kumimoji="0" lang="en-GB" altLang="cs-CZ" b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pression data</a:t>
            </a:r>
            <a:r>
              <a:rPr kumimoji="0" lang="cs-CZ" altLang="cs-CZ" b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generated by Cytoscape 3.8.1</a:t>
            </a:r>
            <a:r>
              <a:rPr lang="cs-CZ" altLang="cs-CZ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altLang="cs-CZ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colour of the genes corresponds to the module to which the gene belongs.</a:t>
            </a:r>
            <a:r>
              <a:rPr lang="cs-CZ" altLang="cs-CZ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djacency treshold for including edges was set on 3. TOM </a:t>
            </a:r>
            <a:r>
              <a:rPr kumimoji="0" lang="en-GB" altLang="cs-CZ" b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trix giving connection strengths among the genes in the network</a:t>
            </a:r>
            <a:r>
              <a:rPr kumimoji="0" lang="cs-CZ" altLang="cs-CZ" b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was generated by function </a:t>
            </a:r>
            <a:r>
              <a:rPr kumimoji="0" lang="cs-CZ" altLang="cs-CZ" b="0" i="1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OMsimilarityFromExpr </a:t>
            </a:r>
            <a:r>
              <a:rPr kumimoji="0" lang="cs-CZ" altLang="cs-CZ" b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rom R package WGCNA with parameters power 6, TOMType signed, networkType singned hybrid and corType pearson.</a:t>
            </a:r>
            <a:endParaRPr kumimoji="0" lang="en-GB" altLang="cs-CZ" b="0" u="none" strike="noStrike" cap="none" normalizeH="0" baseline="0" dirty="0">
              <a:ln>
                <a:noFill/>
              </a:ln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cs-CZ" dirty="0"/>
          </a:p>
        </p:txBody>
      </p:sp>
      <p:pic>
        <p:nvPicPr>
          <p:cNvPr id="4" name="Obrázek 3">
            <a:extLst>
              <a:ext uri="{FF2B5EF4-FFF2-40B4-BE49-F238E27FC236}">
                <a16:creationId xmlns:a16="http://schemas.microsoft.com/office/drawing/2014/main" id="{8E7E1BD7-8AEB-54DC-AE81-EFC0F9347A0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535" t="1" r="31386" b="1334"/>
          <a:stretch/>
        </p:blipFill>
        <p:spPr>
          <a:xfrm>
            <a:off x="245096" y="-1"/>
            <a:ext cx="6787300" cy="68472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2913921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ovéPole 4">
            <a:extLst>
              <a:ext uri="{FF2B5EF4-FFF2-40B4-BE49-F238E27FC236}">
                <a16:creationId xmlns:a16="http://schemas.microsoft.com/office/drawing/2014/main" id="{72B1B0E1-2FDA-DA81-32EF-C29106A71344}"/>
              </a:ext>
            </a:extLst>
          </p:cNvPr>
          <p:cNvSpPr txBox="1"/>
          <p:nvPr/>
        </p:nvSpPr>
        <p:spPr>
          <a:xfrm>
            <a:off x="7187878" y="1643605"/>
            <a:ext cx="3865945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0" lang="en-GB" altLang="cs-CZ" b="1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kumimoji="0" lang="en-GB" altLang="cs-CZ" b="1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GB" altLang="cs-CZ" b="1" strike="noStrike" cap="none" normalizeH="0" baseline="0" dirty="0" err="1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8</a:t>
            </a:r>
            <a:r>
              <a:rPr kumimoji="0" lang="en-GB" altLang="cs-CZ" b="1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kumimoji="0" lang="en-GB" altLang="cs-CZ" b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WGCNA results: Heatmap of relationships between traits and module eigengenes. Colours of cells and upper values in each cell reflect Pearson correlation coefficients. Lower values are </a:t>
            </a:r>
            <a:r>
              <a:rPr kumimoji="0" lang="en-GB" altLang="cs-CZ" b="0" i="1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0" lang="en-GB" altLang="cs-CZ" b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values of the statistical test of this relationship.</a:t>
            </a:r>
            <a:endParaRPr kumimoji="0" lang="en-GB" altLang="cs-CZ" b="0" u="none" strike="noStrike" cap="none" normalizeH="0" baseline="0" dirty="0">
              <a:ln>
                <a:noFill/>
              </a:ln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cs-CZ" dirty="0"/>
          </a:p>
        </p:txBody>
      </p:sp>
      <p:pic>
        <p:nvPicPr>
          <p:cNvPr id="4" name="Obrázek 3">
            <a:extLst>
              <a:ext uri="{FF2B5EF4-FFF2-40B4-BE49-F238E27FC236}">
                <a16:creationId xmlns:a16="http://schemas.microsoft.com/office/drawing/2014/main" id="{CB3397E0-957A-3190-06AB-AC34FF761F9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76823" y="600408"/>
            <a:ext cx="6206523" cy="58003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53649903"/>
      </p:ext>
    </p:extLst>
  </p:cSld>
  <p:clrMapOvr>
    <a:masterClrMapping/>
  </p:clrMapOvr>
</p:sld>
</file>

<file path=ppt/theme/theme1.xml><?xml version="1.0" encoding="utf-8"?>
<a:theme xmlns:a="http://schemas.openxmlformats.org/drawingml/2006/main" name="Motiv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Motiv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69</TotalTime>
  <Words>323</Words>
  <Application>Microsoft Office PowerPoint</Application>
  <PresentationFormat>Widescreen</PresentationFormat>
  <Paragraphs>10</Paragraphs>
  <Slides>9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5" baseType="lpstr">
      <vt:lpstr>Arial</vt:lpstr>
      <vt:lpstr>Calibri</vt:lpstr>
      <vt:lpstr>Calibri Light</vt:lpstr>
      <vt:lpstr>Palatino Linotype</vt:lpstr>
      <vt:lpstr>Times New Roman</vt:lpstr>
      <vt:lpstr>Motiv Office</vt:lpstr>
      <vt:lpstr>Supplementary material figures 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Oldrich Trneny</dc:creator>
  <cp:lastModifiedBy>Vladana Petrovic</cp:lastModifiedBy>
  <cp:revision>60</cp:revision>
  <dcterms:created xsi:type="dcterms:W3CDTF">2019-09-03T09:39:05Z</dcterms:created>
  <dcterms:modified xsi:type="dcterms:W3CDTF">2022-11-25T12:20:58Z</dcterms:modified>
</cp:coreProperties>
</file>